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129" autoAdjust="0"/>
  </p:normalViewPr>
  <p:slideViewPr>
    <p:cSldViewPr>
      <p:cViewPr varScale="1">
        <p:scale>
          <a:sx n="102" d="100"/>
          <a:sy n="102" d="100"/>
        </p:scale>
        <p:origin x="1806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内容占位符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268474525"/>
              </p:ext>
            </p:extLst>
          </p:nvPr>
        </p:nvGraphicFramePr>
        <p:xfrm>
          <a:off x="539552" y="1340768"/>
          <a:ext cx="8229600" cy="37109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</a:tblGrid>
              <a:tr h="1714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igr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nvas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cramble+pcDNA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R-195-5p+pcDNA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R-195-5p+TRIM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cramble+pcDNA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R-195-5p+pcDNA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R-195-5p+TRIM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7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7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6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7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5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2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7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6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5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9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4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4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6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7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5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7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4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3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8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6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4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8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5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3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3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7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6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8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4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1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2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8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5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5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4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4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3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0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5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8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4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2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1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1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6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6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5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3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3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1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5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7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6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1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3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0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8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8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4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3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6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1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5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8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9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5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9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6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2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3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2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4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7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5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7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3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2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7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7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4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1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3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3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5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6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6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22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3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100" u="none" strike="noStrike">
                          <a:effectLst/>
                        </a:rPr>
                        <a:t>1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=21.79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=15.12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=23.8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=9.5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=0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=0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=0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p=0.00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083737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3587" y="3212976"/>
            <a:ext cx="3888432" cy="3645024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3635896" y="40"/>
            <a:ext cx="2520280" cy="648072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/>
              <a:t>Migration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576" y="1700808"/>
            <a:ext cx="2160240" cy="151216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8219" y="1678320"/>
            <a:ext cx="2160240" cy="150876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899592" y="1052736"/>
            <a:ext cx="1925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Scramble+pcDNA3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3491880" y="1052736"/>
            <a:ext cx="2154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miR-195-5p+pcDNA3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6188968" y="1052736"/>
            <a:ext cx="21194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miR-195-5p+TRIM14</a:t>
            </a:r>
            <a:endParaRPr lang="zh-CN" altLang="en-US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1880" y="1700808"/>
            <a:ext cx="2160240" cy="1512168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4882785" y="4321483"/>
            <a:ext cx="498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&amp;&amp;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5906748" y="3881693"/>
            <a:ext cx="498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&amp;&amp;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004604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2604" y="3210055"/>
            <a:ext cx="3515216" cy="3531314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3635896" y="40"/>
            <a:ext cx="2520280" cy="648072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/>
              <a:t>Invasion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899592" y="1052736"/>
            <a:ext cx="1925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Scramble+pcDNA3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3491880" y="1052736"/>
            <a:ext cx="2154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miR-195-5p+pcDNA3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6188968" y="1052736"/>
            <a:ext cx="21194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miR-195-5p+TRIM14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4569258" y="4435708"/>
            <a:ext cx="498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&amp;&amp;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5508104" y="3861048"/>
            <a:ext cx="498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&amp;&amp;</a:t>
            </a:r>
            <a:endParaRPr lang="zh-CN" altLang="en-US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7049" y="1705135"/>
            <a:ext cx="2160240" cy="1507841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0092" y="1705135"/>
            <a:ext cx="2160240" cy="1507841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4185" y="1705135"/>
            <a:ext cx="2160239" cy="15078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7441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18</Words>
  <Application>Microsoft Office PowerPoint</Application>
  <PresentationFormat>全屏显示(4:3)</PresentationFormat>
  <Paragraphs>11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宋体</vt:lpstr>
      <vt:lpstr>Arial</vt:lpstr>
      <vt:lpstr>Calibri</vt:lpstr>
      <vt:lpstr>Office 主题</vt:lpstr>
      <vt:lpstr>PowerPoint 演示文稿</vt:lpstr>
      <vt:lpstr>Migration</vt:lpstr>
      <vt:lpstr>Invas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gration</dc:title>
  <dc:creator>PC</dc:creator>
  <cp:lastModifiedBy>PC</cp:lastModifiedBy>
  <cp:revision>6</cp:revision>
  <dcterms:created xsi:type="dcterms:W3CDTF">2019-08-25T13:17:11Z</dcterms:created>
  <dcterms:modified xsi:type="dcterms:W3CDTF">2019-08-25T13:59:33Z</dcterms:modified>
</cp:coreProperties>
</file>